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99200" cy="10234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021200" y="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  <a:ea typeface="ＭＳ Ｐゴシック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D7F1767-56EF-455E-960E-92EAF224207C}" type="datetime">
              <a:rPr b="0" lang="en-GB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20840" y="767880"/>
            <a:ext cx="2657520" cy="3837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4680" rIns="94680" tIns="47160" bIns="471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  <a:ea typeface="ＭＳ Ｐゴシック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9E6189B-A116-4578-8C01-559CCB3BAA66}" type="slidenum">
              <a:rPr b="0" lang="en-GB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sldImg"/>
          </p:nvPr>
        </p:nvSpPr>
        <p:spPr>
          <a:xfrm>
            <a:off x="2220840" y="768240"/>
            <a:ext cx="2657520" cy="3837240"/>
          </a:xfrm>
          <a:prstGeom prst="rect">
            <a:avLst/>
          </a:prstGeom>
          <a:ln w="0">
            <a:noFill/>
          </a:ln>
        </p:spPr>
      </p:sp>
      <p:sp>
        <p:nvSpPr>
          <p:cNvPr id="92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94680" rIns="94680" tIns="47160" bIns="4716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S.Fig. 1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Gray scale without ‘flattening’ the imag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All panels from a single x-ray film No.2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Slide Number Placeholder 3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4680" rIns="94680" tIns="47160" bIns="4716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63E974A-8088-4A3E-85C4-5A7B7CD5010C}" type="slidenum">
              <a:rPr b="0" lang="en-GB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2BB051-D364-420A-AF4C-DCA07EB43E0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7C9451-BDE0-4352-9203-3DDCC4A0548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9AEF6F-735B-4B20-A382-F970FC88BFC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EA44E0-21C4-488B-B998-00F783D9AA5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8FE1F3-584C-45C7-A9EC-1AB180ABF4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17011C-13E0-4903-9174-AC1CC584B6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5CDCB8-5703-4140-BC1E-5E4D8DDCC0B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0BEB04-AA9F-418E-80CD-847C31970F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444EE7-74FE-4424-B350-7B5AC72E651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42F0BB-0F85-425B-9FEC-645ED86CFF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29648E-FC8D-469B-AB97-E1E66828A7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4A3408-962C-4CE4-989B-0CD3703D3B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ＭＳ Ｐゴシック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3533A09-77F3-4888-8A33-814B3505B59C}" type="datetime">
              <a:rPr b="0" lang="en-GB" sz="1200" spc="-1" strike="noStrike">
                <a:solidFill>
                  <a:srgbClr val="898989"/>
                </a:solidFill>
                <a:latin typeface="Calibri"/>
                <a:ea typeface="ＭＳ Ｐゴシック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ＭＳ Ｐゴシック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ADDDC8F-A947-424B-A7F8-D91B75768637}" type="slidenum">
              <a:rPr b="0" lang="en-GB" sz="1200" spc="-1" strike="noStrike">
                <a:solidFill>
                  <a:srgbClr val="898989"/>
                </a:solidFill>
                <a:latin typeface="Calibri"/>
                <a:ea typeface="ＭＳ Ｐゴシック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slideLayout" Target="../slideLayouts/slideLayout1.xml"/><Relationship Id="rId9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52" descr=""/>
          <p:cNvPicPr/>
          <p:nvPr/>
        </p:nvPicPr>
        <p:blipFill>
          <a:blip r:embed="rId1"/>
          <a:stretch/>
        </p:blipFill>
        <p:spPr>
          <a:xfrm>
            <a:off x="2044800" y="3614760"/>
            <a:ext cx="960480" cy="10875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49" name="Picture 53" descr=""/>
          <p:cNvPicPr/>
          <p:nvPr/>
        </p:nvPicPr>
        <p:blipFill>
          <a:blip r:embed="rId2"/>
          <a:stretch/>
        </p:blipFill>
        <p:spPr>
          <a:xfrm>
            <a:off x="3092400" y="3614760"/>
            <a:ext cx="960480" cy="10875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50" name="Picture 54" descr=""/>
          <p:cNvPicPr/>
          <p:nvPr/>
        </p:nvPicPr>
        <p:blipFill>
          <a:blip r:embed="rId3"/>
          <a:stretch/>
        </p:blipFill>
        <p:spPr>
          <a:xfrm>
            <a:off x="4140360" y="3614760"/>
            <a:ext cx="960120" cy="10875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51" name="Picture 55" descr=""/>
          <p:cNvPicPr/>
          <p:nvPr/>
        </p:nvPicPr>
        <p:blipFill>
          <a:blip r:embed="rId4"/>
          <a:stretch/>
        </p:blipFill>
        <p:spPr>
          <a:xfrm>
            <a:off x="2036880" y="4782960"/>
            <a:ext cx="960480" cy="10875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52" name="Picture 56" descr=""/>
          <p:cNvPicPr/>
          <p:nvPr/>
        </p:nvPicPr>
        <p:blipFill>
          <a:blip r:embed="rId5"/>
          <a:stretch/>
        </p:blipFill>
        <p:spPr>
          <a:xfrm>
            <a:off x="3092400" y="4791240"/>
            <a:ext cx="960480" cy="10872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53" name="Picture 57" descr=""/>
          <p:cNvPicPr/>
          <p:nvPr/>
        </p:nvPicPr>
        <p:blipFill>
          <a:blip r:embed="rId6"/>
          <a:stretch/>
        </p:blipFill>
        <p:spPr>
          <a:xfrm>
            <a:off x="4148280" y="4782960"/>
            <a:ext cx="960120" cy="10875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pic>
        <p:nvPicPr>
          <p:cNvPr id="54" name="Chart 1" descr=""/>
          <p:cNvPicPr/>
          <p:nvPr/>
        </p:nvPicPr>
        <p:blipFill>
          <a:blip r:embed="rId7"/>
          <a:stretch/>
        </p:blipFill>
        <p:spPr>
          <a:xfrm>
            <a:off x="1163520" y="938160"/>
            <a:ext cx="2487600" cy="2530440"/>
          </a:xfrm>
          <a:prstGeom prst="rect">
            <a:avLst/>
          </a:prstGeom>
          <a:ln w="0">
            <a:noFill/>
          </a:ln>
        </p:spPr>
      </p:pic>
      <p:sp>
        <p:nvSpPr>
          <p:cNvPr id="55" name="TextBox 3"/>
          <p:cNvSpPr/>
          <p:nvPr/>
        </p:nvSpPr>
        <p:spPr>
          <a:xfrm>
            <a:off x="3792600" y="965160"/>
            <a:ext cx="360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17"/>
          <p:cNvSpPr/>
          <p:nvPr/>
        </p:nvSpPr>
        <p:spPr>
          <a:xfrm>
            <a:off x="1647720" y="2995560"/>
            <a:ext cx="390600" cy="550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18"/>
          <p:cNvSpPr/>
          <p:nvPr/>
        </p:nvSpPr>
        <p:spPr>
          <a:xfrm>
            <a:off x="1975680" y="2997360"/>
            <a:ext cx="342360" cy="550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D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19"/>
          <p:cNvSpPr/>
          <p:nvPr/>
        </p:nvSpPr>
        <p:spPr>
          <a:xfrm>
            <a:off x="2283840" y="2995560"/>
            <a:ext cx="342360" cy="550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20"/>
          <p:cNvSpPr/>
          <p:nvPr/>
        </p:nvSpPr>
        <p:spPr>
          <a:xfrm>
            <a:off x="2579040" y="2995560"/>
            <a:ext cx="342360" cy="550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21"/>
          <p:cNvSpPr/>
          <p:nvPr/>
        </p:nvSpPr>
        <p:spPr>
          <a:xfrm>
            <a:off x="2883960" y="2995560"/>
            <a:ext cx="342360" cy="550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22"/>
          <p:cNvSpPr/>
          <p:nvPr/>
        </p:nvSpPr>
        <p:spPr>
          <a:xfrm>
            <a:off x="3183840" y="2987640"/>
            <a:ext cx="342360" cy="550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23"/>
          <p:cNvSpPr/>
          <p:nvPr/>
        </p:nvSpPr>
        <p:spPr>
          <a:xfrm>
            <a:off x="1220760" y="892080"/>
            <a:ext cx="2463840" cy="358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24"/>
          <p:cNvSpPr/>
          <p:nvPr/>
        </p:nvSpPr>
        <p:spPr>
          <a:xfrm>
            <a:off x="1275840" y="1062000"/>
            <a:ext cx="37872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(%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3"/>
          <p:cNvSpPr/>
          <p:nvPr/>
        </p:nvSpPr>
        <p:spPr>
          <a:xfrm>
            <a:off x="907920" y="957240"/>
            <a:ext cx="19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461"/>
          <p:cNvSpPr/>
          <p:nvPr/>
        </p:nvSpPr>
        <p:spPr>
          <a:xfrm rot="16200000">
            <a:off x="312120" y="1998720"/>
            <a:ext cx="17953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elative mtDNA copy numb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3"/>
          <p:cNvSpPr/>
          <p:nvPr/>
        </p:nvSpPr>
        <p:spPr>
          <a:xfrm>
            <a:off x="2708280" y="6578640"/>
            <a:ext cx="2971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uhanen et al., Supplementary Figure 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60"/>
          <p:cNvSpPr/>
          <p:nvPr/>
        </p:nvSpPr>
        <p:spPr>
          <a:xfrm>
            <a:off x="1490400" y="3441600"/>
            <a:ext cx="27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Oval 50"/>
          <p:cNvSpPr/>
          <p:nvPr/>
        </p:nvSpPr>
        <p:spPr>
          <a:xfrm>
            <a:off x="4292640" y="1639800"/>
            <a:ext cx="1025640" cy="1025640"/>
          </a:xfrm>
          <a:prstGeom prst="ellipse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AutoShape 64"/>
          <p:cNvSpPr/>
          <p:nvPr/>
        </p:nvSpPr>
        <p:spPr>
          <a:xfrm rot="19338000">
            <a:off x="5148360" y="2531880"/>
            <a:ext cx="71280" cy="7452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960" bIns="-21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AutoShape 65"/>
          <p:cNvSpPr/>
          <p:nvPr/>
        </p:nvSpPr>
        <p:spPr>
          <a:xfrm rot="8290200">
            <a:off x="4403520" y="1688400"/>
            <a:ext cx="71280" cy="730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2320" bIns="-223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55"/>
          <p:cNvSpPr/>
          <p:nvPr/>
        </p:nvSpPr>
        <p:spPr>
          <a:xfrm>
            <a:off x="4059360" y="1468440"/>
            <a:ext cx="57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,049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56"/>
          <p:cNvSpPr/>
          <p:nvPr/>
        </p:nvSpPr>
        <p:spPr>
          <a:xfrm>
            <a:off x="4602240" y="1636560"/>
            <a:ext cx="393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9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57"/>
          <p:cNvSpPr/>
          <p:nvPr/>
        </p:nvSpPr>
        <p:spPr>
          <a:xfrm>
            <a:off x="4857840" y="1360440"/>
            <a:ext cx="788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6,0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58"/>
          <p:cNvSpPr/>
          <p:nvPr/>
        </p:nvSpPr>
        <p:spPr>
          <a:xfrm>
            <a:off x="5330880" y="1924200"/>
            <a:ext cx="658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2,27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61"/>
          <p:cNvSpPr/>
          <p:nvPr/>
        </p:nvSpPr>
        <p:spPr>
          <a:xfrm>
            <a:off x="4420800" y="1951200"/>
            <a:ext cx="74160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uma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mtDN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6,569 b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74"/>
          <p:cNvSpPr/>
          <p:nvPr/>
        </p:nvSpPr>
        <p:spPr>
          <a:xfrm>
            <a:off x="4802040" y="1601640"/>
            <a:ext cx="0" cy="76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74"/>
          <p:cNvSpPr/>
          <p:nvPr/>
        </p:nvSpPr>
        <p:spPr>
          <a:xfrm>
            <a:off x="5156280" y="2502000"/>
            <a:ext cx="689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0,41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Arc 58"/>
          <p:cNvSpPr/>
          <p:nvPr/>
        </p:nvSpPr>
        <p:spPr>
          <a:xfrm>
            <a:off x="4287960" y="1638360"/>
            <a:ext cx="1027080" cy="1025640"/>
          </a:xfrm>
          <a:custGeom>
            <a:avLst/>
            <a:gdLst>
              <a:gd name="textAreaLeft" fmla="*/ 668520 w 1027080"/>
              <a:gd name="textAreaRight" fmla="*/ 1022760 w 1027080"/>
              <a:gd name="textAreaTop" fmla="*/ 23760 h 1025640"/>
              <a:gd name="textAreaBottom" fmla="*/ 443880 h 1025640"/>
            </a:gdLst>
            <a:ahLst/>
            <a:rect l="textAreaLeft" t="textAreaTop" r="textAreaRight" b="textAreaBottom"/>
            <a:pathLst>
              <a:path stroke="0" w="1027112" h="1025525">
                <a:moveTo>
                  <a:pt x="668416" y="23868"/>
                </a:moveTo>
                <a:lnTo>
                  <a:pt x="668416" y="23868"/>
                </a:lnTo>
                <a:arcTo wR="513556" hR="512763" stAng="-4345448" swAng="3883377"/>
                <a:lnTo>
                  <a:pt x="513556" y="512763"/>
                </a:lnTo>
                <a:close/>
              </a:path>
              <a:path fill="none" w="1027112" h="1025525">
                <a:moveTo>
                  <a:pt x="668416" y="23868"/>
                </a:moveTo>
                <a:lnTo>
                  <a:pt x="668416" y="23868"/>
                </a:lnTo>
                <a:arcTo wR="513556" hR="512763" stAng="-4345448" swAng="3883377"/>
              </a:path>
            </a:pathLst>
          </a:custGeom>
          <a:noFill/>
          <a:ln w="38160">
            <a:solidFill>
              <a:srgbClr val="7f7f7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AutoShape 62"/>
          <p:cNvSpPr/>
          <p:nvPr/>
        </p:nvSpPr>
        <p:spPr>
          <a:xfrm rot="11895600">
            <a:off x="4935240" y="1574640"/>
            <a:ext cx="71280" cy="7488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600" bIns="-21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AutoShape 63"/>
          <p:cNvSpPr/>
          <p:nvPr/>
        </p:nvSpPr>
        <p:spPr>
          <a:xfrm rot="15804600">
            <a:off x="5325120" y="2045520"/>
            <a:ext cx="69840" cy="7452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21960" bIns="-21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Box 25"/>
          <p:cNvSpPr/>
          <p:nvPr/>
        </p:nvSpPr>
        <p:spPr>
          <a:xfrm>
            <a:off x="2716200" y="3592440"/>
            <a:ext cx="357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ffffff"/>
                </a:solidFill>
                <a:latin typeface="Arial"/>
                <a:ea typeface="ＭＳ Ｐゴシック"/>
              </a:rPr>
              <a:t>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Box 26"/>
          <p:cNvSpPr/>
          <p:nvPr/>
        </p:nvSpPr>
        <p:spPr>
          <a:xfrm>
            <a:off x="3767400" y="3584520"/>
            <a:ext cx="34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ffffff"/>
                </a:solidFill>
                <a:latin typeface="Arial"/>
                <a:ea typeface="ＭＳ Ｐゴシック"/>
              </a:rPr>
              <a:t>D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Box 27"/>
          <p:cNvSpPr/>
          <p:nvPr/>
        </p:nvSpPr>
        <p:spPr>
          <a:xfrm>
            <a:off x="4813200" y="3584520"/>
            <a:ext cx="366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ffffff"/>
                </a:solidFill>
                <a:latin typeface="Arial"/>
                <a:ea typeface="ＭＳ Ｐゴシック"/>
              </a:rPr>
              <a:t>R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28"/>
          <p:cNvSpPr/>
          <p:nvPr/>
        </p:nvSpPr>
        <p:spPr>
          <a:xfrm>
            <a:off x="2719440" y="4759200"/>
            <a:ext cx="34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ffffff"/>
                </a:solidFill>
                <a:latin typeface="Arial"/>
                <a:ea typeface="ＭＳ Ｐゴシック"/>
              </a:rPr>
              <a:t>R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29"/>
          <p:cNvSpPr/>
          <p:nvPr/>
        </p:nvSpPr>
        <p:spPr>
          <a:xfrm>
            <a:off x="3759480" y="4759200"/>
            <a:ext cx="34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ffffff"/>
                </a:solidFill>
                <a:latin typeface="Arial"/>
                <a:ea typeface="ＭＳ Ｐゴシック"/>
              </a:rPr>
              <a:t>R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Box 30"/>
          <p:cNvSpPr/>
          <p:nvPr/>
        </p:nvSpPr>
        <p:spPr>
          <a:xfrm>
            <a:off x="4815720" y="4759200"/>
            <a:ext cx="34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ffffff"/>
                </a:solidFill>
                <a:latin typeface="Arial"/>
                <a:ea typeface="ＭＳ Ｐゴシック"/>
              </a:rPr>
              <a:t>R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Box 25"/>
          <p:cNvSpPr/>
          <p:nvPr/>
        </p:nvSpPr>
        <p:spPr>
          <a:xfrm>
            <a:off x="2771640" y="3903840"/>
            <a:ext cx="192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ffffff"/>
                </a:solidFill>
                <a:latin typeface="Arial"/>
                <a:ea typeface="ＭＳ Ｐゴシック"/>
              </a:rPr>
              <a:t>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Straight Connector 100"/>
          <p:cNvSpPr/>
          <p:nvPr/>
        </p:nvSpPr>
        <p:spPr>
          <a:xfrm flipV="1">
            <a:off x="2737800" y="4061880"/>
            <a:ext cx="82440" cy="874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Straight Connector 103"/>
          <p:cNvSpPr/>
          <p:nvPr/>
        </p:nvSpPr>
        <p:spPr>
          <a:xfrm flipV="1">
            <a:off x="2510640" y="3920760"/>
            <a:ext cx="81000" cy="8748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25"/>
          <p:cNvSpPr/>
          <p:nvPr/>
        </p:nvSpPr>
        <p:spPr>
          <a:xfrm>
            <a:off x="2535120" y="3746520"/>
            <a:ext cx="265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ffffff"/>
                </a:solidFill>
                <a:latin typeface="Arial"/>
                <a:ea typeface="ＭＳ Ｐゴシック"/>
              </a:rPr>
              <a:t>i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0-17T14:52:44Z</dcterms:created>
  <dc:creator>rmgzyta</dc:creator>
  <dc:description/>
  <dc:language>en-US</dc:language>
  <cp:lastModifiedBy>rmgzyta</cp:lastModifiedBy>
  <dcterms:modified xsi:type="dcterms:W3CDTF">2011-05-12T17:46:31Z</dcterms:modified>
  <cp:revision>230</cp:revision>
  <dc:subject/>
  <dc:title>Slide 1</dc:title>
</cp:coreProperties>
</file>